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9" r:id="rId2"/>
  </p:sldIdLst>
  <p:sldSz cx="7864475" cy="8778875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BFBFBF"/>
    <a:srgbClr val="D9D9D9"/>
    <a:srgbClr val="CC00CC"/>
    <a:srgbClr val="00CC00"/>
    <a:srgbClr val="7F7F7F"/>
    <a:srgbClr val="A6A6A6"/>
    <a:srgbClr val="FF9966"/>
    <a:srgbClr val="FFFF00"/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2496" y="198"/>
      </p:cViewPr>
      <p:guideLst>
        <p:guide orient="horz" pos="1517"/>
        <p:guide pos="4493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Qing%20Li\Documents\Project%20at%20UIUC\QingLi_2011-2012\Arabidopsis%20haploid\1manuscript\20141026\Figure%20sx%20TE%20distance%20to%20gene%20and%20TE%20family%20on%20mRNA%20inheritance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6.133474169387363E-2"/>
          <c:y val="2.2893929303613357E-2"/>
          <c:w val="0.69975257665962565"/>
          <c:h val="0.74487013750147524"/>
        </c:manualLayout>
      </c:layout>
      <c:lineChart>
        <c:grouping val="standard"/>
        <c:varyColors val="0"/>
        <c:ser>
          <c:idx val="2"/>
          <c:order val="0"/>
          <c:tx>
            <c:v>TE_LPMP</c:v>
          </c:tx>
          <c:spPr>
            <a:ln>
              <a:solidFill>
                <a:schemeClr val="accent6">
                  <a:lumMod val="75000"/>
                </a:schemeClr>
              </a:solidFill>
            </a:ln>
          </c:spPr>
          <c:marker>
            <c:symbol val="circle"/>
            <c:size val="5"/>
            <c:spPr>
              <a:solidFill>
                <a:schemeClr val="accent6">
                  <a:lumMod val="75000"/>
                </a:schemeClr>
              </a:solidFill>
              <a:ln>
                <a:noFill/>
              </a:ln>
            </c:spPr>
          </c:marker>
          <c:cat>
            <c:strRef>
              <c:f>'C:\Users\Qing Li\Documents\Arabidopsis haploid\TEenrich_20121105\[TE_genic sRNA_20121106.xlsx]decay'!$D$46:$D$56</c:f>
              <c:strCache>
                <c:ptCount val="11"/>
                <c:pt idx="0">
                  <c:v>4-5k_up</c:v>
                </c:pt>
                <c:pt idx="1">
                  <c:v>3-4k_up</c:v>
                </c:pt>
                <c:pt idx="2">
                  <c:v>2-3k_up</c:v>
                </c:pt>
                <c:pt idx="3">
                  <c:v>1-2k_up</c:v>
                </c:pt>
                <c:pt idx="4">
                  <c:v>0-1k_up</c:v>
                </c:pt>
                <c:pt idx="5">
                  <c:v>body</c:v>
                </c:pt>
                <c:pt idx="6">
                  <c:v>0-1k_down</c:v>
                </c:pt>
                <c:pt idx="7">
                  <c:v>1-2k_down</c:v>
                </c:pt>
                <c:pt idx="8">
                  <c:v>2-3k_down</c:v>
                </c:pt>
                <c:pt idx="9">
                  <c:v>3-4k_down</c:v>
                </c:pt>
                <c:pt idx="10">
                  <c:v>4-5k_down</c:v>
                </c:pt>
              </c:strCache>
            </c:strRef>
          </c:cat>
          <c:val>
            <c:numRef>
              <c:f>'Figure S3'!$G$24:$G$34</c:f>
              <c:numCache>
                <c:formatCode>General</c:formatCode>
                <c:ptCount val="11"/>
                <c:pt idx="0">
                  <c:v>3.5602094240837672</c:v>
                </c:pt>
                <c:pt idx="1">
                  <c:v>3.735325506937035</c:v>
                </c:pt>
                <c:pt idx="2">
                  <c:v>4.5356371490280774</c:v>
                </c:pt>
                <c:pt idx="3">
                  <c:v>4.6324269889224565</c:v>
                </c:pt>
                <c:pt idx="4">
                  <c:v>5.1515151515151478</c:v>
                </c:pt>
                <c:pt idx="5">
                  <c:v>7.0967741935483897</c:v>
                </c:pt>
                <c:pt idx="6">
                  <c:v>4.5787545787545785</c:v>
                </c:pt>
                <c:pt idx="7">
                  <c:v>4.3720930232558137</c:v>
                </c:pt>
                <c:pt idx="8">
                  <c:v>5.0200803212851381</c:v>
                </c:pt>
                <c:pt idx="9">
                  <c:v>4.0423484119345563</c:v>
                </c:pt>
                <c:pt idx="10">
                  <c:v>4.6488625123639959</c:v>
                </c:pt>
              </c:numCache>
            </c:numRef>
          </c:val>
          <c:smooth val="0"/>
        </c:ser>
        <c:ser>
          <c:idx val="6"/>
          <c:order val="1"/>
          <c:tx>
            <c:v>No TE_LPMP</c:v>
          </c:tx>
          <c:spPr>
            <a:ln>
              <a:solidFill>
                <a:schemeClr val="accent6">
                  <a:lumMod val="75000"/>
                </a:schemeClr>
              </a:solidFill>
              <a:prstDash val="sysDot"/>
            </a:ln>
          </c:spPr>
          <c:marker>
            <c:symbol val="circle"/>
            <c:size val="5"/>
            <c:spPr>
              <a:solidFill>
                <a:schemeClr val="accent6">
                  <a:lumMod val="75000"/>
                </a:schemeClr>
              </a:solidFill>
              <a:ln>
                <a:noFill/>
              </a:ln>
            </c:spPr>
          </c:marker>
          <c:cat>
            <c:strRef>
              <c:f>'C:\Users\Qing Li\Documents\Arabidopsis haploid\TEenrich_20121105\[TE_genic sRNA_20121106.xlsx]decay'!$D$46:$D$56</c:f>
              <c:strCache>
                <c:ptCount val="11"/>
                <c:pt idx="0">
                  <c:v>4-5k_up</c:v>
                </c:pt>
                <c:pt idx="1">
                  <c:v>3-4k_up</c:v>
                </c:pt>
                <c:pt idx="2">
                  <c:v>2-3k_up</c:v>
                </c:pt>
                <c:pt idx="3">
                  <c:v>1-2k_up</c:v>
                </c:pt>
                <c:pt idx="4">
                  <c:v>0-1k_up</c:v>
                </c:pt>
                <c:pt idx="5">
                  <c:v>body</c:v>
                </c:pt>
                <c:pt idx="6">
                  <c:v>0-1k_down</c:v>
                </c:pt>
                <c:pt idx="7">
                  <c:v>1-2k_down</c:v>
                </c:pt>
                <c:pt idx="8">
                  <c:v>2-3k_down</c:v>
                </c:pt>
                <c:pt idx="9">
                  <c:v>3-4k_down</c:v>
                </c:pt>
                <c:pt idx="10">
                  <c:v>4-5k_down</c:v>
                </c:pt>
              </c:strCache>
            </c:strRef>
          </c:cat>
          <c:val>
            <c:numRef>
              <c:f>'Figure S3'!$H$24:$H$34</c:f>
              <c:numCache>
                <c:formatCode>General</c:formatCode>
                <c:ptCount val="11"/>
                <c:pt idx="0">
                  <c:v>2.659232253913788</c:v>
                </c:pt>
                <c:pt idx="1">
                  <c:v>2.6276436658833582</c:v>
                </c:pt>
                <c:pt idx="2">
                  <c:v>2.4722932651321399</c:v>
                </c:pt>
                <c:pt idx="3">
                  <c:v>2.4216216216216218</c:v>
                </c:pt>
                <c:pt idx="4">
                  <c:v>2.3120138288677601</c:v>
                </c:pt>
                <c:pt idx="5">
                  <c:v>2.2809123649459799</c:v>
                </c:pt>
                <c:pt idx="6">
                  <c:v>2.3862129916040633</c:v>
                </c:pt>
                <c:pt idx="7">
                  <c:v>2.443319392471937</c:v>
                </c:pt>
                <c:pt idx="8">
                  <c:v>2.3366508005192532</c:v>
                </c:pt>
                <c:pt idx="9">
                  <c:v>2.5333042148940819</c:v>
                </c:pt>
                <c:pt idx="10">
                  <c:v>2.4093770349468198</c:v>
                </c:pt>
              </c:numCache>
            </c:numRef>
          </c:val>
          <c:smooth val="0"/>
        </c:ser>
        <c:ser>
          <c:idx val="3"/>
          <c:order val="2"/>
          <c:tx>
            <c:v>TE_LP</c:v>
          </c:tx>
          <c:spPr>
            <a:ln>
              <a:solidFill>
                <a:srgbClr val="FF0000"/>
              </a:solidFill>
            </a:ln>
          </c:spPr>
          <c:marker>
            <c:symbol val="circle"/>
            <c:size val="7"/>
            <c:spPr>
              <a:solidFill>
                <a:srgbClr val="FF0000"/>
              </a:solidFill>
              <a:ln>
                <a:noFill/>
              </a:ln>
            </c:spPr>
          </c:marker>
          <c:cat>
            <c:strRef>
              <c:f>'C:\Users\Qing Li\Documents\Arabidopsis haploid\TEenrich_20121105\[TE_genic sRNA_20121106.xlsx]decay'!$D$46:$D$56</c:f>
              <c:strCache>
                <c:ptCount val="11"/>
                <c:pt idx="0">
                  <c:v>4-5k_up</c:v>
                </c:pt>
                <c:pt idx="1">
                  <c:v>3-4k_up</c:v>
                </c:pt>
                <c:pt idx="2">
                  <c:v>2-3k_up</c:v>
                </c:pt>
                <c:pt idx="3">
                  <c:v>1-2k_up</c:v>
                </c:pt>
                <c:pt idx="4">
                  <c:v>0-1k_up</c:v>
                </c:pt>
                <c:pt idx="5">
                  <c:v>body</c:v>
                </c:pt>
                <c:pt idx="6">
                  <c:v>0-1k_down</c:v>
                </c:pt>
                <c:pt idx="7">
                  <c:v>1-2k_down</c:v>
                </c:pt>
                <c:pt idx="8">
                  <c:v>2-3k_down</c:v>
                </c:pt>
                <c:pt idx="9">
                  <c:v>3-4k_down</c:v>
                </c:pt>
                <c:pt idx="10">
                  <c:v>4-5k_down</c:v>
                </c:pt>
              </c:strCache>
            </c:strRef>
          </c:cat>
          <c:val>
            <c:numRef>
              <c:f>'Figure S3'!$G$13:$G$23</c:f>
              <c:numCache>
                <c:formatCode>General</c:formatCode>
                <c:ptCount val="11"/>
                <c:pt idx="0">
                  <c:v>18.429319371727722</c:v>
                </c:pt>
                <c:pt idx="1">
                  <c:v>19.423692636072563</c:v>
                </c:pt>
                <c:pt idx="2">
                  <c:v>17.386609071274279</c:v>
                </c:pt>
                <c:pt idx="3">
                  <c:v>17.82477341389729</c:v>
                </c:pt>
                <c:pt idx="4">
                  <c:v>16.868686868686869</c:v>
                </c:pt>
                <c:pt idx="5">
                  <c:v>19.677419354838708</c:v>
                </c:pt>
                <c:pt idx="6">
                  <c:v>15.476190476190473</c:v>
                </c:pt>
                <c:pt idx="7">
                  <c:v>16.186046511627886</c:v>
                </c:pt>
                <c:pt idx="8">
                  <c:v>16.867469879518072</c:v>
                </c:pt>
                <c:pt idx="9">
                  <c:v>17.516843118383061</c:v>
                </c:pt>
                <c:pt idx="10">
                  <c:v>20.276953511374877</c:v>
                </c:pt>
              </c:numCache>
            </c:numRef>
          </c:val>
          <c:smooth val="0"/>
        </c:ser>
        <c:ser>
          <c:idx val="7"/>
          <c:order val="3"/>
          <c:tx>
            <c:v>No_LP</c:v>
          </c:tx>
          <c:spPr>
            <a:ln>
              <a:solidFill>
                <a:srgbClr val="FF0000"/>
              </a:solidFill>
              <a:prstDash val="sysDot"/>
            </a:ln>
          </c:spPr>
          <c:marker>
            <c:symbol val="circle"/>
            <c:size val="5"/>
            <c:spPr>
              <a:solidFill>
                <a:srgbClr val="FF0000"/>
              </a:solidFill>
              <a:ln>
                <a:noFill/>
              </a:ln>
            </c:spPr>
          </c:marker>
          <c:cat>
            <c:strRef>
              <c:f>'C:\Users\Qing Li\Documents\Arabidopsis haploid\TEenrich_20121105\[TE_genic sRNA_20121106.xlsx]decay'!$D$46:$D$56</c:f>
              <c:strCache>
                <c:ptCount val="11"/>
                <c:pt idx="0">
                  <c:v>4-5k_up</c:v>
                </c:pt>
                <c:pt idx="1">
                  <c:v>3-4k_up</c:v>
                </c:pt>
                <c:pt idx="2">
                  <c:v>2-3k_up</c:v>
                </c:pt>
                <c:pt idx="3">
                  <c:v>1-2k_up</c:v>
                </c:pt>
                <c:pt idx="4">
                  <c:v>0-1k_up</c:v>
                </c:pt>
                <c:pt idx="5">
                  <c:v>body</c:v>
                </c:pt>
                <c:pt idx="6">
                  <c:v>0-1k_down</c:v>
                </c:pt>
                <c:pt idx="7">
                  <c:v>1-2k_down</c:v>
                </c:pt>
                <c:pt idx="8">
                  <c:v>2-3k_down</c:v>
                </c:pt>
                <c:pt idx="9">
                  <c:v>3-4k_down</c:v>
                </c:pt>
                <c:pt idx="10">
                  <c:v>4-5k_down</c:v>
                </c:pt>
              </c:strCache>
            </c:strRef>
          </c:cat>
          <c:val>
            <c:numRef>
              <c:f>'Figure S3'!$H$13:$H$23</c:f>
              <c:numCache>
                <c:formatCode>General</c:formatCode>
                <c:ptCount val="11"/>
                <c:pt idx="0">
                  <c:v>17.220673386232029</c:v>
                </c:pt>
                <c:pt idx="1">
                  <c:v>17.026276436658833</c:v>
                </c:pt>
                <c:pt idx="2">
                  <c:v>17.433930093776642</c:v>
                </c:pt>
                <c:pt idx="3">
                  <c:v>17.340540540540523</c:v>
                </c:pt>
                <c:pt idx="4">
                  <c:v>17.545375972342253</c:v>
                </c:pt>
                <c:pt idx="5">
                  <c:v>17.146858743497422</c:v>
                </c:pt>
                <c:pt idx="6">
                  <c:v>17.89659743703049</c:v>
                </c:pt>
                <c:pt idx="7">
                  <c:v>17.719568567026194</c:v>
                </c:pt>
                <c:pt idx="8">
                  <c:v>17.546516659454781</c:v>
                </c:pt>
                <c:pt idx="9">
                  <c:v>17.405547062677428</c:v>
                </c:pt>
                <c:pt idx="10">
                  <c:v>16.80052094638592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3296256"/>
        <c:axId val="43298176"/>
      </c:lineChart>
      <c:catAx>
        <c:axId val="43296256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 rot="5400000"/>
          <a:lstStyle/>
          <a:p>
            <a:pPr>
              <a:defRPr/>
            </a:pPr>
            <a:endParaRPr lang="en-US"/>
          </a:p>
        </c:txPr>
        <c:crossAx val="43298176"/>
        <c:crosses val="autoZero"/>
        <c:auto val="1"/>
        <c:lblAlgn val="ctr"/>
        <c:lblOffset val="100"/>
        <c:noMultiLvlLbl val="0"/>
      </c:catAx>
      <c:valAx>
        <c:axId val="4329817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43296256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3127712160979863"/>
          <c:y val="0.11159661012522692"/>
          <c:w val="0.26872287839020176"/>
          <c:h val="0.37257810221638982"/>
        </c:manualLayout>
      </c:layout>
      <c:overlay val="0"/>
      <c:txPr>
        <a:bodyPr/>
        <a:lstStyle/>
        <a:p>
          <a:pPr>
            <a:defRPr sz="900"/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txPr>
    <a:bodyPr/>
    <a:lstStyle/>
    <a:p>
      <a:pPr>
        <a:defRPr sz="1200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D2C9D4C-51EA-45DB-B9CA-E78420898B6F}" type="datetimeFigureOut">
              <a:rPr lang="en-US" smtClean="0"/>
              <a:pPr/>
              <a:t>2/12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892300" y="685800"/>
            <a:ext cx="30734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7B35B42-A990-4A5C-838A-C4F422C2772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74425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9839" y="2727141"/>
            <a:ext cx="6684803" cy="1881768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79675" y="4974696"/>
            <a:ext cx="5505133" cy="224349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701747" y="351565"/>
            <a:ext cx="1769507" cy="749049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93224" y="351565"/>
            <a:ext cx="5177446" cy="749049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1243" y="5641241"/>
            <a:ext cx="6684803" cy="174358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1243" y="3720863"/>
            <a:ext cx="6684803" cy="1920378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93224" y="2048405"/>
            <a:ext cx="3473476" cy="579365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97775" y="2048405"/>
            <a:ext cx="3473476" cy="579365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93225" y="1965090"/>
            <a:ext cx="3474842" cy="81895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225" y="2784046"/>
            <a:ext cx="3474842" cy="50580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95049" y="1965090"/>
            <a:ext cx="3476207" cy="81895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95049" y="2784046"/>
            <a:ext cx="3476207" cy="50580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2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2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2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93225" y="349530"/>
            <a:ext cx="2587358" cy="148753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74792" y="349533"/>
            <a:ext cx="4396460" cy="749252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93225" y="1837066"/>
            <a:ext cx="2587358" cy="6004995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41495" y="6145216"/>
            <a:ext cx="4718685" cy="72547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541495" y="784411"/>
            <a:ext cx="4718685" cy="52673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41495" y="6870691"/>
            <a:ext cx="4718685" cy="103029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93227" y="351562"/>
            <a:ext cx="7078027" cy="146314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93227" y="2048405"/>
            <a:ext cx="7078027" cy="579365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93224" y="8136717"/>
            <a:ext cx="1835044" cy="46739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2/1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87033" y="8136717"/>
            <a:ext cx="2490417" cy="46739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636207" y="8136717"/>
            <a:ext cx="1835044" cy="46739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Chart 7"/>
          <p:cNvGraphicFramePr/>
          <p:nvPr/>
        </p:nvGraphicFramePr>
        <p:xfrm>
          <a:off x="960437" y="579437"/>
          <a:ext cx="4572000" cy="21945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 rot="16200000">
            <a:off x="-199813" y="1181312"/>
            <a:ext cx="1905001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 smtClean="0">
                <a:latin typeface="Arial" pitchFamily="34" charset="0"/>
                <a:cs typeface="Arial" pitchFamily="34" charset="0"/>
              </a:rPr>
              <a:t>% genes with </a:t>
            </a:r>
            <a:r>
              <a:rPr lang="en-US" sz="1050" dirty="0" smtClean="0">
                <a:latin typeface="Arial" pitchFamily="34" charset="0"/>
                <a:cs typeface="Arial" pitchFamily="34" charset="0"/>
              </a:rPr>
              <a:t>LP/LPMP </a:t>
            </a:r>
            <a:r>
              <a:rPr lang="en-US" sz="1050" dirty="0" smtClean="0">
                <a:latin typeface="Arial" pitchFamily="34" charset="0"/>
                <a:cs typeface="Arial" pitchFamily="34" charset="0"/>
              </a:rPr>
              <a:t>inheritance for mRNA</a:t>
            </a:r>
            <a:endParaRPr lang="en-US" sz="105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560637" y="2713037"/>
            <a:ext cx="134143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 smtClean="0">
                <a:latin typeface="Arial" pitchFamily="34" charset="0"/>
                <a:cs typeface="Arial" pitchFamily="34" charset="0"/>
              </a:rPr>
              <a:t>TE position</a:t>
            </a:r>
            <a:endParaRPr lang="en-US" sz="105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07</TotalTime>
  <Words>9</Words>
  <Application>Microsoft Office PowerPoint</Application>
  <PresentationFormat>Custom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Qing Li</dc:creator>
  <cp:lastModifiedBy>Qing Li</cp:lastModifiedBy>
  <cp:revision>359</cp:revision>
  <dcterms:created xsi:type="dcterms:W3CDTF">2006-08-16T00:00:00Z</dcterms:created>
  <dcterms:modified xsi:type="dcterms:W3CDTF">2015-02-13T00:53:58Z</dcterms:modified>
</cp:coreProperties>
</file>